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66" d="100"/>
          <a:sy n="66" d="100"/>
        </p:scale>
        <p:origin x="592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6372-EDDC-4C96-81C0-EE98175663A9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8EEA3-0E96-49C7-8E9A-967D846777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7067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6372-EDDC-4C96-81C0-EE98175663A9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8EEA3-0E96-49C7-8E9A-967D846777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3455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6372-EDDC-4C96-81C0-EE98175663A9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8EEA3-0E96-49C7-8E9A-967D846777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3647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6372-EDDC-4C96-81C0-EE98175663A9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8EEA3-0E96-49C7-8E9A-967D846777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1541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6372-EDDC-4C96-81C0-EE98175663A9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8EEA3-0E96-49C7-8E9A-967D846777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4063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6372-EDDC-4C96-81C0-EE98175663A9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8EEA3-0E96-49C7-8E9A-967D846777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8457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6372-EDDC-4C96-81C0-EE98175663A9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8EEA3-0E96-49C7-8E9A-967D846777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2030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6372-EDDC-4C96-81C0-EE98175663A9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8EEA3-0E96-49C7-8E9A-967D846777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8390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6372-EDDC-4C96-81C0-EE98175663A9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8EEA3-0E96-49C7-8E9A-967D846777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5133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6372-EDDC-4C96-81C0-EE98175663A9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8EEA3-0E96-49C7-8E9A-967D846777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703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6372-EDDC-4C96-81C0-EE98175663A9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8EEA3-0E96-49C7-8E9A-967D846777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0264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F6372-EDDC-4C96-81C0-EE98175663A9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E8EEA3-0E96-49C7-8E9A-967D846777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3626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ounded Rectangle 19"/>
          <p:cNvSpPr/>
          <p:nvPr/>
        </p:nvSpPr>
        <p:spPr>
          <a:xfrm>
            <a:off x="51638" y="2405004"/>
            <a:ext cx="4148888" cy="3274275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85937" y="1498758"/>
            <a:ext cx="3856674" cy="923330"/>
          </a:xfrm>
          <a:prstGeom prst="rect">
            <a:avLst/>
          </a:prstGeom>
          <a:noFill/>
          <a:ln w="19050">
            <a:solidFill>
              <a:schemeClr val="bg2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="1" dirty="0">
                <a:solidFill>
                  <a:prstClr val="black"/>
                </a:solidFill>
                <a:latin typeface="Calibri" panose="020F0502020204030204"/>
              </a:rPr>
              <a:t>Socio-environmental drivers of vulnerability to climate-and water sensitive infectious diseases</a:t>
            </a: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1" name="Flowchart: Connector 20"/>
          <p:cNvSpPr/>
          <p:nvPr/>
        </p:nvSpPr>
        <p:spPr>
          <a:xfrm>
            <a:off x="804308" y="2430593"/>
            <a:ext cx="1620000" cy="1620000"/>
          </a:xfrm>
          <a:prstGeom prst="flowChartConnector">
            <a:avLst/>
          </a:prstGeom>
          <a:solidFill>
            <a:schemeClr val="accent4">
              <a:lumMod val="40000"/>
              <a:lumOff val="60000"/>
              <a:alpha val="60000"/>
            </a:schemeClr>
          </a:solidFill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22491" y="2480844"/>
            <a:ext cx="211048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limat</a:t>
            </a:r>
            <a:r>
              <a:rPr lang="en-GB" sz="1600" b="1" dirty="0">
                <a:solidFill>
                  <a:prstClr val="black"/>
                </a:solidFill>
                <a:latin typeface="Calibri" panose="020F0502020204030204"/>
              </a:rPr>
              <a:t>e</a:t>
            </a:r>
            <a:endParaRPr kumimoji="0" lang="en-GB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azard 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715004" y="2363331"/>
            <a:ext cx="161410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sease risks</a:t>
            </a: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or</a:t>
            </a: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andless</a:t>
            </a: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omen &amp; children</a:t>
            </a:r>
          </a:p>
        </p:txBody>
      </p:sp>
      <p:sp>
        <p:nvSpPr>
          <p:cNvPr id="28" name="Flowchart: Connector 27"/>
          <p:cNvSpPr/>
          <p:nvPr/>
        </p:nvSpPr>
        <p:spPr>
          <a:xfrm>
            <a:off x="130720" y="3381456"/>
            <a:ext cx="1692000" cy="1692000"/>
          </a:xfrm>
          <a:prstGeom prst="flowChartConnector">
            <a:avLst/>
          </a:prstGeom>
          <a:solidFill>
            <a:srgbClr val="E59993">
              <a:alpha val="60000"/>
            </a:srgbClr>
          </a:solidFill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2" name="Flowchart: Connector 21"/>
          <p:cNvSpPr/>
          <p:nvPr/>
        </p:nvSpPr>
        <p:spPr>
          <a:xfrm>
            <a:off x="1357227" y="3372850"/>
            <a:ext cx="1692000" cy="1692000"/>
          </a:xfrm>
          <a:prstGeom prst="flowChartConnector">
            <a:avLst/>
          </a:prstGeom>
          <a:solidFill>
            <a:srgbClr val="CCCCFF">
              <a:alpha val="60000"/>
            </a:srgbClr>
          </a:solidFill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317676" y="4018885"/>
            <a:ext cx="946061" cy="3898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isk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981612" y="2981983"/>
            <a:ext cx="17981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.g. hydrological,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gricultural 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45120" y="3883999"/>
            <a:ext cx="108379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xposure humans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 impacts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789374" y="3981982"/>
            <a:ext cx="1276686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5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ulnerability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5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&amp; Adaptive capacity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93297" y="5113841"/>
            <a:ext cx="41239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isk perceptions, priorities, coping strategies</a:t>
            </a:r>
          </a:p>
        </p:txBody>
      </p:sp>
      <p:sp>
        <p:nvSpPr>
          <p:cNvPr id="39" name="Rounded Rectangle 38"/>
          <p:cNvSpPr/>
          <p:nvPr/>
        </p:nvSpPr>
        <p:spPr>
          <a:xfrm>
            <a:off x="8434978" y="2351593"/>
            <a:ext cx="3652575" cy="1980403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8550409" y="2441819"/>
            <a:ext cx="3443976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0" lvl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pportunities </a:t>
            </a:r>
            <a:r>
              <a:rPr lang="en-GB" sz="2000" dirty="0">
                <a:solidFill>
                  <a:prstClr val="black"/>
                </a:solidFill>
                <a:latin typeface="Calibri" panose="020F0502020204030204"/>
              </a:rPr>
              <a:t>for i</a:t>
            </a:r>
            <a:r>
              <a:rPr kumimoji="0" lang="en-GB" sz="2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tegrated</a:t>
            </a:r>
            <a:r>
              <a:rPr kumimoji="0" lang="en-GB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lang="en-GB" sz="2000" dirty="0">
                <a:solidFill>
                  <a:prstClr val="black"/>
                </a:solidFill>
                <a:latin typeface="Calibri" panose="020F0502020204030204"/>
              </a:rPr>
              <a:t>cross-sectoral forecasting and surveillance systems that are contextually relevant and appropriate</a:t>
            </a: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lang="en-GB" dirty="0">
              <a:solidFill>
                <a:prstClr val="black"/>
              </a:solidFill>
              <a:latin typeface="Calibri" panose="020F0502020204030204"/>
            </a:endParaRP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3" name="Right Arrow 52"/>
          <p:cNvSpPr/>
          <p:nvPr/>
        </p:nvSpPr>
        <p:spPr>
          <a:xfrm rot="8032810">
            <a:off x="3252290" y="964326"/>
            <a:ext cx="942369" cy="29647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4" name="Right Arrow 53"/>
          <p:cNvSpPr/>
          <p:nvPr/>
        </p:nvSpPr>
        <p:spPr>
          <a:xfrm rot="2517682">
            <a:off x="8607256" y="1424381"/>
            <a:ext cx="1606528" cy="37370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7" name="Up-Down Arrow 56"/>
          <p:cNvSpPr/>
          <p:nvPr/>
        </p:nvSpPr>
        <p:spPr>
          <a:xfrm>
            <a:off x="7797066" y="2978768"/>
            <a:ext cx="183624" cy="1980404"/>
          </a:xfrm>
          <a:prstGeom prst="up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783400" y="3024248"/>
            <a:ext cx="2963932" cy="2308324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2400" dirty="0">
                <a:solidFill>
                  <a:prstClr val="black"/>
                </a:solidFill>
                <a:latin typeface="Calibri" panose="020F0502020204030204"/>
              </a:rPr>
              <a:t>Mapping existing cross-sectoral forecasting and surveillance capacities and  needs across the south Asia region </a:t>
            </a:r>
            <a:endParaRPr kumimoji="0" lang="en-GB" sz="1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4" name="Circular Arrow 63"/>
          <p:cNvSpPr/>
          <p:nvPr/>
        </p:nvSpPr>
        <p:spPr>
          <a:xfrm>
            <a:off x="3769591" y="2430593"/>
            <a:ext cx="1086130" cy="1111893"/>
          </a:xfrm>
          <a:prstGeom prst="circular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5" name="Up-Down Arrow 64"/>
          <p:cNvSpPr/>
          <p:nvPr/>
        </p:nvSpPr>
        <p:spPr>
          <a:xfrm>
            <a:off x="4560983" y="3043440"/>
            <a:ext cx="183624" cy="1980404"/>
          </a:xfrm>
          <a:prstGeom prst="up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6" name="Circular Arrow 65"/>
          <p:cNvSpPr/>
          <p:nvPr/>
        </p:nvSpPr>
        <p:spPr>
          <a:xfrm>
            <a:off x="7658159" y="2287266"/>
            <a:ext cx="1086130" cy="1111893"/>
          </a:xfrm>
          <a:prstGeom prst="circular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8183676" y="4359007"/>
            <a:ext cx="3938742" cy="120032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9050">
            <a:solidFill>
              <a:schemeClr val="accent6">
                <a:lumMod val="20000"/>
                <a:lumOff val="80000"/>
              </a:scheme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nhanced disease control and multi-sectoral adaptive capacity</a:t>
            </a:r>
          </a:p>
        </p:txBody>
      </p:sp>
      <p:sp>
        <p:nvSpPr>
          <p:cNvPr id="72" name="Right Arrow 71"/>
          <p:cNvSpPr/>
          <p:nvPr/>
        </p:nvSpPr>
        <p:spPr>
          <a:xfrm rot="13283833">
            <a:off x="9126139" y="1285525"/>
            <a:ext cx="1767772" cy="37370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4272FA4-EA2A-610B-9BC6-9F917C750D29}"/>
              </a:ext>
            </a:extLst>
          </p:cNvPr>
          <p:cNvSpPr txBox="1"/>
          <p:nvPr/>
        </p:nvSpPr>
        <p:spPr>
          <a:xfrm>
            <a:off x="4127601" y="556017"/>
            <a:ext cx="4616215" cy="461665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2400" b="1" dirty="0">
                <a:solidFill>
                  <a:prstClr val="black"/>
                </a:solidFill>
                <a:latin typeface="Calibri" panose="020F0502020204030204"/>
              </a:rPr>
              <a:t>Climate variability and change </a:t>
            </a:r>
            <a:endParaRPr kumimoji="0" lang="en-GB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964285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81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stus Asaaga</dc:creator>
  <cp:lastModifiedBy>Festus Asaaga</cp:lastModifiedBy>
  <cp:revision>1</cp:revision>
  <dcterms:created xsi:type="dcterms:W3CDTF">2023-11-07T15:00:37Z</dcterms:created>
  <dcterms:modified xsi:type="dcterms:W3CDTF">2023-11-07T16:19:25Z</dcterms:modified>
</cp:coreProperties>
</file>